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5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12"/>
    <p:restoredTop sz="94694"/>
  </p:normalViewPr>
  <p:slideViewPr>
    <p:cSldViewPr snapToGrid="0">
      <p:cViewPr>
        <p:scale>
          <a:sx n="101" d="100"/>
          <a:sy n="101" d="100"/>
        </p:scale>
        <p:origin x="3008" y="6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4" d="100"/>
        <a:sy n="144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324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7324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9792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2360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8664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00131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9601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336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1870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4119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1341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22979-1254-497D-A692-B30FC75CEC18}" type="datetimeFigureOut">
              <a:rPr lang="en-AU" smtClean="0"/>
              <a:t>24/8/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24069-7C46-4CD4-8B52-06DB49943AE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693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text on a black background&#10;&#10;Description automatically generated">
            <a:extLst>
              <a:ext uri="{FF2B5EF4-FFF2-40B4-BE49-F238E27FC236}">
                <a16:creationId xmlns:a16="http://schemas.microsoft.com/office/drawing/2014/main" id="{D056B8DC-6598-9843-B74E-5547D2D32E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914" y="0"/>
            <a:ext cx="4570003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DD625FB-F227-A940-8F6C-B68B315287C7}"/>
              </a:ext>
            </a:extLst>
          </p:cNvPr>
          <p:cNvSpPr txBox="1"/>
          <p:nvPr/>
        </p:nvSpPr>
        <p:spPr>
          <a:xfrm>
            <a:off x="5370557" y="38014"/>
            <a:ext cx="362939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sequence alignment of the </a:t>
            </a:r>
            <a:r>
              <a:rPr lang="en-AU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AU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cum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 13032 protein NCgl2761 and putative orthologs in </a:t>
            </a:r>
            <a:r>
              <a:rPr lang="en-AU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tuberculosis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37Rv (Rv0226c), </a:t>
            </a:r>
            <a:r>
              <a:rPr lang="en-AU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smegmatis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</a:t>
            </a:r>
            <a:r>
              <a:rPr lang="en-AU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5 (MSMEG_0315) and </a:t>
            </a:r>
            <a:r>
              <a:rPr lang="en-AU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leprae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L2582). 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es indicated by * and reverse shaded are completely conserved among the sequences; those indicated by . or : and shaded grey are similar. Predicted transmembrane domains within NCgl2761 are underlined and numbered. Predicted NCgl2761 signal peptide is shown in bold. Alignment was created using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.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3799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58510F-E79A-E348-9E11-667DF0A0FA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6822" y="2951417"/>
            <a:ext cx="3436610" cy="247435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53BA39F-E195-C440-AEB3-06019E3284E0}"/>
              </a:ext>
            </a:extLst>
          </p:cNvPr>
          <p:cNvSpPr/>
          <p:nvPr/>
        </p:nvSpPr>
        <p:spPr>
          <a:xfrm>
            <a:off x="428329" y="5447822"/>
            <a:ext cx="845004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u="sng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AU" sz="1200" b="1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oglycan analysis of a </a:t>
            </a:r>
            <a:r>
              <a:rPr lang="en-AU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gl2761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A)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acrylamide gel electrophoresis (PAGE) analysis of silver stained polar glycolipids extracted from WT 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A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cum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ne 1), Δ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gl2761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(lane 2) and Δ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gl2760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. Lipoarabinomannans (LAM) and lipomannans (LM) and a truncated LM species (t-LM) are indicated. M, molecular weight protein markers.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AU" sz="1200" b="1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F-MS profiling of LM samples from WT and </a:t>
            </a:r>
            <a:r>
              <a:rPr lang="en-AU" sz="1200" b="1" i="1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gl2761</a:t>
            </a:r>
            <a:r>
              <a:rPr lang="en-AU" sz="1200" b="1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tant. </a:t>
            </a:r>
            <a:r>
              <a:rPr lang="en-AU" sz="1200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rified LM/LAM samples from WT and </a:t>
            </a:r>
            <a:r>
              <a:rPr lang="en-AU" sz="1200" i="1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gl2761</a:t>
            </a:r>
            <a:r>
              <a:rPr lang="en-AU" sz="1200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tant were </a:t>
            </a:r>
            <a:r>
              <a:rPr lang="en-AU" sz="1200" dirty="0" err="1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n-AU" sz="1200" dirty="0">
                <a:solidFill>
                  <a:srgbClr val="14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y direct infusion TOF-MS in negative ion mode. Individual LM species were identified based on their exact mass after deconvolution and mass difference (by m/z 162 or 324) from related LM species containing the same lipid moieties. The plots show the mass (m/z) of all detected species and predicted mannan chain length (number of mannose residues).</a:t>
            </a:r>
          </a:p>
        </p:txBody>
      </p:sp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47CB85BE-3F3E-A645-B1AC-2E1D9688C7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426" y="2806993"/>
            <a:ext cx="3476346" cy="26779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7503000-1D42-6B43-9DDD-2F2D2FF1B973}"/>
              </a:ext>
            </a:extLst>
          </p:cNvPr>
          <p:cNvSpPr txBox="1"/>
          <p:nvPr/>
        </p:nvSpPr>
        <p:spPr>
          <a:xfrm>
            <a:off x="2230417" y="334093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W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9552D8-8556-7945-A86B-2B269A72B2B8}"/>
              </a:ext>
            </a:extLst>
          </p:cNvPr>
          <p:cNvSpPr txBox="1"/>
          <p:nvPr/>
        </p:nvSpPr>
        <p:spPr>
          <a:xfrm>
            <a:off x="5616964" y="3340938"/>
            <a:ext cx="1024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△</a:t>
            </a:r>
            <a:r>
              <a:rPr lang="en-US" sz="1400" i="1"/>
              <a:t>NCgl2761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13BADA38-AFB0-A748-BCC6-DD160586E92D}"/>
              </a:ext>
            </a:extLst>
          </p:cNvPr>
          <p:cNvGrpSpPr/>
          <p:nvPr/>
        </p:nvGrpSpPr>
        <p:grpSpPr>
          <a:xfrm>
            <a:off x="888500" y="51505"/>
            <a:ext cx="5073599" cy="2770922"/>
            <a:chOff x="1392357" y="1740912"/>
            <a:chExt cx="5073599" cy="2770922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7463B7C-4F74-8F47-81DD-3A4DDCBB58E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4199" y="2301134"/>
              <a:ext cx="1519857" cy="22107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97A15BE-2B81-9448-9FAE-EC5190D92CC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5611" y="2301134"/>
              <a:ext cx="2256757" cy="2210700"/>
            </a:xfrm>
            <a:prstGeom prst="rect">
              <a:avLst/>
            </a:prstGeom>
          </p:spPr>
        </p:pic>
        <p:sp>
          <p:nvSpPr>
            <p:cNvPr id="12" name="Textfeld 23">
              <a:extLst>
                <a:ext uri="{FF2B5EF4-FFF2-40B4-BE49-F238E27FC236}">
                  <a16:creationId xmlns:a16="http://schemas.microsoft.com/office/drawing/2014/main" id="{C316D7B9-6EEE-1441-B0AF-EAEA116B91A6}"/>
                </a:ext>
              </a:extLst>
            </p:cNvPr>
            <p:cNvSpPr txBox="1"/>
            <p:nvPr/>
          </p:nvSpPr>
          <p:spPr>
            <a:xfrm>
              <a:off x="1460936" y="410832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24">
              <a:extLst>
                <a:ext uri="{FF2B5EF4-FFF2-40B4-BE49-F238E27FC236}">
                  <a16:creationId xmlns:a16="http://schemas.microsoft.com/office/drawing/2014/main" id="{B62DA4A3-4AE8-8044-AADB-CB85AB01F23D}"/>
                </a:ext>
              </a:extLst>
            </p:cNvPr>
            <p:cNvSpPr txBox="1"/>
            <p:nvPr/>
          </p:nvSpPr>
          <p:spPr>
            <a:xfrm>
              <a:off x="1460936" y="346923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25">
              <a:extLst>
                <a:ext uri="{FF2B5EF4-FFF2-40B4-BE49-F238E27FC236}">
                  <a16:creationId xmlns:a16="http://schemas.microsoft.com/office/drawing/2014/main" id="{F900B94B-8CC5-A347-BD79-5907560415BD}"/>
                </a:ext>
              </a:extLst>
            </p:cNvPr>
            <p:cNvSpPr txBox="1"/>
            <p:nvPr/>
          </p:nvSpPr>
          <p:spPr>
            <a:xfrm>
              <a:off x="1468136" y="289054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26">
              <a:extLst>
                <a:ext uri="{FF2B5EF4-FFF2-40B4-BE49-F238E27FC236}">
                  <a16:creationId xmlns:a16="http://schemas.microsoft.com/office/drawing/2014/main" id="{39930883-E7BF-A640-A9A4-5D15D86A7629}"/>
                </a:ext>
              </a:extLst>
            </p:cNvPr>
            <p:cNvSpPr txBox="1"/>
            <p:nvPr/>
          </p:nvSpPr>
          <p:spPr>
            <a:xfrm>
              <a:off x="1468136" y="244517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9">
              <a:extLst>
                <a:ext uri="{FF2B5EF4-FFF2-40B4-BE49-F238E27FC236}">
                  <a16:creationId xmlns:a16="http://schemas.microsoft.com/office/drawing/2014/main" id="{259756CA-CBD4-A146-B1C5-F74ADD53C5E9}"/>
                </a:ext>
              </a:extLst>
            </p:cNvPr>
            <p:cNvSpPr txBox="1"/>
            <p:nvPr/>
          </p:nvSpPr>
          <p:spPr>
            <a:xfrm>
              <a:off x="2622181" y="1740912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7" name="Textfeld 10">
              <a:extLst>
                <a:ext uri="{FF2B5EF4-FFF2-40B4-BE49-F238E27FC236}">
                  <a16:creationId xmlns:a16="http://schemas.microsoft.com/office/drawing/2014/main" id="{1DAB156B-1019-F54D-8251-CAE6564DC0C1}"/>
                </a:ext>
              </a:extLst>
            </p:cNvPr>
            <p:cNvSpPr txBox="1"/>
            <p:nvPr/>
          </p:nvSpPr>
          <p:spPr>
            <a:xfrm>
              <a:off x="5806472" y="2468645"/>
              <a:ext cx="6286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LAM</a:t>
              </a:r>
            </a:p>
          </p:txBody>
        </p:sp>
        <p:sp>
          <p:nvSpPr>
            <p:cNvPr id="18" name="Textfeld 9">
              <a:extLst>
                <a:ext uri="{FF2B5EF4-FFF2-40B4-BE49-F238E27FC236}">
                  <a16:creationId xmlns:a16="http://schemas.microsoft.com/office/drawing/2014/main" id="{9C8F88FA-CCCD-D245-8A94-AF06C0CA9AAA}"/>
                </a:ext>
              </a:extLst>
            </p:cNvPr>
            <p:cNvSpPr txBox="1"/>
            <p:nvPr/>
          </p:nvSpPr>
          <p:spPr>
            <a:xfrm>
              <a:off x="3370872" y="1745659"/>
              <a:ext cx="11015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GB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NCgl2761</a:t>
              </a:r>
            </a:p>
          </p:txBody>
        </p:sp>
        <p:sp>
          <p:nvSpPr>
            <p:cNvPr id="19" name="Textfeld 9">
              <a:extLst>
                <a:ext uri="{FF2B5EF4-FFF2-40B4-BE49-F238E27FC236}">
                  <a16:creationId xmlns:a16="http://schemas.microsoft.com/office/drawing/2014/main" id="{C5419EB7-646E-8140-B3CE-37A7511E0F4A}"/>
                </a:ext>
              </a:extLst>
            </p:cNvPr>
            <p:cNvSpPr txBox="1"/>
            <p:nvPr/>
          </p:nvSpPr>
          <p:spPr>
            <a:xfrm>
              <a:off x="2368406" y="2032323"/>
              <a:ext cx="9981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og        St</a:t>
              </a:r>
            </a:p>
          </p:txBody>
        </p:sp>
        <p:sp>
          <p:nvSpPr>
            <p:cNvPr id="20" name="Textfeld 9">
              <a:extLst>
                <a:ext uri="{FF2B5EF4-FFF2-40B4-BE49-F238E27FC236}">
                  <a16:creationId xmlns:a16="http://schemas.microsoft.com/office/drawing/2014/main" id="{03FE928C-D0D5-B347-8C72-952678A46EB5}"/>
                </a:ext>
              </a:extLst>
            </p:cNvPr>
            <p:cNvSpPr txBox="1"/>
            <p:nvPr/>
          </p:nvSpPr>
          <p:spPr>
            <a:xfrm>
              <a:off x="3476253" y="2024133"/>
              <a:ext cx="10402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og        St</a:t>
              </a:r>
            </a:p>
          </p:txBody>
        </p:sp>
        <p:sp>
          <p:nvSpPr>
            <p:cNvPr id="21" name="Textfeld 9">
              <a:extLst>
                <a:ext uri="{FF2B5EF4-FFF2-40B4-BE49-F238E27FC236}">
                  <a16:creationId xmlns:a16="http://schemas.microsoft.com/office/drawing/2014/main" id="{64EF4C93-08EB-1A47-9FA6-92872BE6C0E5}"/>
                </a:ext>
              </a:extLst>
            </p:cNvPr>
            <p:cNvSpPr txBox="1"/>
            <p:nvPr/>
          </p:nvSpPr>
          <p:spPr>
            <a:xfrm>
              <a:off x="4580202" y="1746820"/>
              <a:ext cx="11015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GB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NCgl2760</a:t>
              </a:r>
            </a:p>
          </p:txBody>
        </p:sp>
        <p:sp>
          <p:nvSpPr>
            <p:cNvPr id="22" name="Textfeld 9">
              <a:extLst>
                <a:ext uri="{FF2B5EF4-FFF2-40B4-BE49-F238E27FC236}">
                  <a16:creationId xmlns:a16="http://schemas.microsoft.com/office/drawing/2014/main" id="{E9C44A13-36A8-A245-BD6D-696F7D31CB3F}"/>
                </a:ext>
              </a:extLst>
            </p:cNvPr>
            <p:cNvSpPr txBox="1"/>
            <p:nvPr/>
          </p:nvSpPr>
          <p:spPr>
            <a:xfrm>
              <a:off x="4595020" y="2024133"/>
              <a:ext cx="9947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og        St</a:t>
              </a:r>
            </a:p>
          </p:txBody>
        </p:sp>
        <p:sp>
          <p:nvSpPr>
            <p:cNvPr id="23" name="Textfeld 10">
              <a:extLst>
                <a:ext uri="{FF2B5EF4-FFF2-40B4-BE49-F238E27FC236}">
                  <a16:creationId xmlns:a16="http://schemas.microsoft.com/office/drawing/2014/main" id="{6A3CC1CE-A766-E541-ACEE-16A31A8D93B0}"/>
                </a:ext>
              </a:extLst>
            </p:cNvPr>
            <p:cNvSpPr txBox="1"/>
            <p:nvPr/>
          </p:nvSpPr>
          <p:spPr>
            <a:xfrm>
              <a:off x="5830695" y="3318850"/>
              <a:ext cx="4812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LM</a:t>
              </a:r>
            </a:p>
          </p:txBody>
        </p:sp>
        <p:sp>
          <p:nvSpPr>
            <p:cNvPr id="24" name="Textfeld 10">
              <a:extLst>
                <a:ext uri="{FF2B5EF4-FFF2-40B4-BE49-F238E27FC236}">
                  <a16:creationId xmlns:a16="http://schemas.microsoft.com/office/drawing/2014/main" id="{C067CCBD-E78B-B540-AD45-C4441968C041}"/>
                </a:ext>
              </a:extLst>
            </p:cNvPr>
            <p:cNvSpPr txBox="1"/>
            <p:nvPr/>
          </p:nvSpPr>
          <p:spPr>
            <a:xfrm>
              <a:off x="5846876" y="3692184"/>
              <a:ext cx="6190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t-LM</a:t>
              </a: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EBEA8B2D-3C67-544B-BFB8-07CA78D0E548}"/>
                </a:ext>
              </a:extLst>
            </p:cNvPr>
            <p:cNvCxnSpPr>
              <a:cxnSpLocks/>
            </p:cNvCxnSpPr>
            <p:nvPr/>
          </p:nvCxnSpPr>
          <p:spPr>
            <a:xfrm>
              <a:off x="3378411" y="1805834"/>
              <a:ext cx="0" cy="270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C474F90-52AB-5C47-A6B5-DA223C176607}"/>
                </a:ext>
              </a:extLst>
            </p:cNvPr>
            <p:cNvCxnSpPr>
              <a:cxnSpLocks/>
              <a:endCxn id="11" idx="2"/>
            </p:cNvCxnSpPr>
            <p:nvPr/>
          </p:nvCxnSpPr>
          <p:spPr>
            <a:xfrm flipH="1">
              <a:off x="4513990" y="1805834"/>
              <a:ext cx="38072" cy="270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86FDC42E-2ABC-A943-8932-A1840DB6B684}"/>
                </a:ext>
              </a:extLst>
            </p:cNvPr>
            <p:cNvCxnSpPr>
              <a:cxnSpLocks/>
            </p:cNvCxnSpPr>
            <p:nvPr/>
          </p:nvCxnSpPr>
          <p:spPr>
            <a:xfrm>
              <a:off x="2357961" y="1805834"/>
              <a:ext cx="0" cy="270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1621E75D-A557-9D4C-87F9-7324D5855C5E}"/>
                </a:ext>
              </a:extLst>
            </p:cNvPr>
            <p:cNvSpPr/>
            <p:nvPr/>
          </p:nvSpPr>
          <p:spPr>
            <a:xfrm>
              <a:off x="1854199" y="2301132"/>
              <a:ext cx="3799020" cy="22106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feld 26">
              <a:extLst>
                <a:ext uri="{FF2B5EF4-FFF2-40B4-BE49-F238E27FC236}">
                  <a16:creationId xmlns:a16="http://schemas.microsoft.com/office/drawing/2014/main" id="{57CEA13C-D027-3243-ADA5-CE29D642FCA5}"/>
                </a:ext>
              </a:extLst>
            </p:cNvPr>
            <p:cNvSpPr txBox="1"/>
            <p:nvPr/>
          </p:nvSpPr>
          <p:spPr>
            <a:xfrm>
              <a:off x="1392357" y="2106838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9">
              <a:extLst>
                <a:ext uri="{FF2B5EF4-FFF2-40B4-BE49-F238E27FC236}">
                  <a16:creationId xmlns:a16="http://schemas.microsoft.com/office/drawing/2014/main" id="{291341C1-092D-6147-BB3E-49BFC55B18ED}"/>
                </a:ext>
              </a:extLst>
            </p:cNvPr>
            <p:cNvSpPr txBox="1"/>
            <p:nvPr/>
          </p:nvSpPr>
          <p:spPr>
            <a:xfrm>
              <a:off x="1948280" y="1747280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6C630C3-8928-3549-9561-4E00828CBDC1}"/>
                </a:ext>
              </a:extLst>
            </p:cNvPr>
            <p:cNvCxnSpPr>
              <a:cxnSpLocks/>
            </p:cNvCxnSpPr>
            <p:nvPr/>
          </p:nvCxnSpPr>
          <p:spPr>
            <a:xfrm>
              <a:off x="5823715" y="2445172"/>
              <a:ext cx="1" cy="3413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99A2DC8-D617-1848-B320-0110BA23C7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28275" y="2454172"/>
              <a:ext cx="10475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A0324EAB-B147-F947-A3BE-74F0832956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31092" y="2779991"/>
              <a:ext cx="10475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1FBEACD7-4670-854E-8D1B-B7AC6BF918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0023" y="3872232"/>
              <a:ext cx="21809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7C7A2BEE-3DF6-A641-AFE0-7AA777A15B9E}"/>
                </a:ext>
              </a:extLst>
            </p:cNvPr>
            <p:cNvCxnSpPr>
              <a:cxnSpLocks/>
            </p:cNvCxnSpPr>
            <p:nvPr/>
          </p:nvCxnSpPr>
          <p:spPr>
            <a:xfrm>
              <a:off x="5839011" y="3331376"/>
              <a:ext cx="1" cy="3413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21188996-D504-2545-8766-C70FF3F10E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3571" y="3340376"/>
              <a:ext cx="10475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00A0FEE-AFC4-D14E-8D94-F356377701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388" y="3666195"/>
              <a:ext cx="10475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0E33DA22-36A9-BA43-BD31-3D95013A5297}"/>
              </a:ext>
            </a:extLst>
          </p:cNvPr>
          <p:cNvSpPr txBox="1"/>
          <p:nvPr/>
        </p:nvSpPr>
        <p:spPr>
          <a:xfrm>
            <a:off x="428329" y="15811"/>
            <a:ext cx="4413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/>
              <a:t>A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6991350-52B8-E345-A29C-EEC7051465AD}"/>
              </a:ext>
            </a:extLst>
          </p:cNvPr>
          <p:cNvSpPr txBox="1"/>
          <p:nvPr/>
        </p:nvSpPr>
        <p:spPr>
          <a:xfrm>
            <a:off x="451537" y="2816496"/>
            <a:ext cx="4283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760752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17</TotalTime>
  <Words>287</Words>
  <Application>Microsoft Macintosh PowerPoint</Application>
  <PresentationFormat>On-screen Show (4:3)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mmycashmore</dc:creator>
  <cp:lastModifiedBy>Microsoft Office User</cp:lastModifiedBy>
  <cp:revision>235</cp:revision>
  <dcterms:created xsi:type="dcterms:W3CDTF">2015-07-17T21:17:07Z</dcterms:created>
  <dcterms:modified xsi:type="dcterms:W3CDTF">2021-08-24T03:00:33Z</dcterms:modified>
</cp:coreProperties>
</file>